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7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</p:sldIdLst>
  <p:sldSz cx="9144000" cy="6858000"/>
  <p:notesSz cx="10194925" cy="13460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0" y="0"/>
            <a:ext cx="10195200" cy="13460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4416480" cy="6714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 type="dt" idx="7"/>
          </p:nvPr>
        </p:nvSpPr>
        <p:spPr>
          <a:xfrm>
            <a:off x="5773680" y="-360"/>
            <a:ext cx="4417920" cy="6714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PlaceHolder 3"/>
          <p:cNvSpPr>
            <a:spLocks noGrp="1"/>
          </p:cNvSpPr>
          <p:nvPr>
            <p:ph type="sldImg"/>
          </p:nvPr>
        </p:nvSpPr>
        <p:spPr>
          <a:xfrm>
            <a:off x="1730160" y="1009440"/>
            <a:ext cx="6730920" cy="504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ffffff"/>
                </a:solidFill>
                <a:latin typeface="Arial"/>
              </a:rPr>
              <a:t>Click to move the slide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PlaceHolder 4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5"/>
          <p:cNvSpPr>
            <a:spLocks noGrp="1"/>
          </p:cNvSpPr>
          <p:nvPr>
            <p:ph type="ftr" idx="8"/>
          </p:nvPr>
        </p:nvSpPr>
        <p:spPr>
          <a:xfrm>
            <a:off x="0" y="12783960"/>
            <a:ext cx="4416480" cy="6732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PlaceHolder 6"/>
          <p:cNvSpPr>
            <a:spLocks noGrp="1"/>
          </p:cNvSpPr>
          <p:nvPr>
            <p:ph type="sldNum" idx="9"/>
          </p:nvPr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b">
            <a:noAutofit/>
          </a:bodyPr>
          <a:lstStyle>
            <a:lvl1pPr marL="216000" indent="0" algn="r">
              <a:buNone/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  <a:defRPr b="0" lang="en-US" sz="1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ECFFEAF7-5D9B-4160-9500-94F4535A2793}" type="slidenum"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70404DC7-C12A-4A98-BF94-59F595B7D6D1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66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54FFE7BD-872E-43C5-8D49-50BFAFE4107C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69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hanges to your lifesty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g more active, eating more healthi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50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lide Number Placeholder 3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A48F3825-53D4-4B90-9A76-38ECD43AB88D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D1E7FA1D-2F5A-4DA6-ABE5-FD9814E49F10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54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fer to leaflet at this stage. Each tip has an explanation and then some handy hi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222768B7-4369-4EE9-A812-B8FBD41F979E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4FCE4A21-9D75-4F60-B742-6DBCADCAF14C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lanning increases likelihood that behaviour will be perform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fer to logbook at this st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Rectangle 7"/>
          <p:cNvSpPr/>
          <p:nvPr/>
        </p:nvSpPr>
        <p:spPr>
          <a:xfrm>
            <a:off x="5773680" y="12783960"/>
            <a:ext cx="441792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b">
            <a:noAutofit/>
          </a:bodyPr>
          <a:p>
            <a:pPr algn="r">
              <a:tabLst>
                <a:tab algn="l" pos="0"/>
                <a:tab algn="l" pos="1349280"/>
                <a:tab algn="l" pos="2698920"/>
                <a:tab algn="l" pos="4048200"/>
                <a:tab algn="l" pos="5397480"/>
                <a:tab algn="l" pos="6746760"/>
                <a:tab algn="l" pos="8096400"/>
                <a:tab algn="l" pos="9445680"/>
                <a:tab algn="l" pos="10794960"/>
              </a:tabLst>
            </a:pPr>
            <a:fld id="{DA6C8691-0097-4F14-99B8-350D51A5A31E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1"/>
          <p:cNvSpPr>
            <a:spLocks noGrp="1"/>
          </p:cNvSpPr>
          <p:nvPr>
            <p:ph type="sldImg"/>
          </p:nvPr>
        </p:nvSpPr>
        <p:spPr>
          <a:xfrm>
            <a:off x="1730520" y="1009800"/>
            <a:ext cx="6730920" cy="5048280"/>
          </a:xfrm>
          <a:prstGeom prst="rect">
            <a:avLst/>
          </a:prstGeom>
          <a:ln w="0">
            <a:noFill/>
          </a:ln>
        </p:spPr>
      </p:sp>
      <p:sp>
        <p:nvSpPr>
          <p:cNvPr id="163" name="PlaceHolder 2"/>
          <p:cNvSpPr>
            <a:spLocks noGrp="1"/>
          </p:cNvSpPr>
          <p:nvPr>
            <p:ph type="body"/>
          </p:nvPr>
        </p:nvSpPr>
        <p:spPr>
          <a:xfrm>
            <a:off x="1018800" y="6392520"/>
            <a:ext cx="8155080" cy="605628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o I thought we could have a go at thinking how we could fit these tips into our daily lives?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 have got the ideas that our volunteers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dentifie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so what they could change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 to help them achieve these tip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What I would like to do now is get some of your thoughts on HOW we could achieve this!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sk audience – ‘What could we do to fit more walking into our journey to work?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7B7E6-FC53-43CF-8799-14947BFBC1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609480" y="390852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62105-E004-4130-B202-EB6C7448BE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6702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F9742-9C86-4759-B8DA-54D095013E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328896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596880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60948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328896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596880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2A63D-8423-46FC-AABE-9358C27FDE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3E2BCE6-B6AE-4281-94A4-6D5F12D0F8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subTitle"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AA53F42-E3F9-483E-B053-60896EE702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A56A950-A426-4AB1-A836-49FD6AB395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CFE8248-AC00-45B3-AC61-3CA59FF299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4F4CB53-151E-473D-9F6E-6D2393F9C9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ubTitle"/>
          </p:nvPr>
        </p:nvSpPr>
        <p:spPr>
          <a:xfrm>
            <a:off x="194760" y="228600"/>
            <a:ext cx="801540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E9F9AD-C5F5-412C-889A-4E01E93E53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7B9F641-3CDC-4BBA-945C-D7E7F0BEF5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EADED-4491-4236-BAC9-113E826B24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6702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CDB23E1-9D69-4D5B-8401-B0B4355E7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E85E06-8FE8-4172-838B-D9BA71746B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609480" y="390852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D0F0DD-AFDB-4FDE-A8A8-3E9E01E6E3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/>
          </p:nvPr>
        </p:nvSpPr>
        <p:spPr>
          <a:xfrm>
            <a:off x="46702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32ED500-09DF-4C2F-872A-DE47492587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3"/>
          <p:cNvSpPr>
            <a:spLocks noGrp="1"/>
          </p:cNvSpPr>
          <p:nvPr>
            <p:ph/>
          </p:nvPr>
        </p:nvSpPr>
        <p:spPr>
          <a:xfrm>
            <a:off x="328896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4"/>
          <p:cNvSpPr>
            <a:spLocks noGrp="1"/>
          </p:cNvSpPr>
          <p:nvPr>
            <p:ph/>
          </p:nvPr>
        </p:nvSpPr>
        <p:spPr>
          <a:xfrm>
            <a:off x="5968800" y="159984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5"/>
          <p:cNvSpPr>
            <a:spLocks noGrp="1"/>
          </p:cNvSpPr>
          <p:nvPr>
            <p:ph/>
          </p:nvPr>
        </p:nvSpPr>
        <p:spPr>
          <a:xfrm>
            <a:off x="60948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6"/>
          <p:cNvSpPr>
            <a:spLocks noGrp="1"/>
          </p:cNvSpPr>
          <p:nvPr>
            <p:ph/>
          </p:nvPr>
        </p:nvSpPr>
        <p:spPr>
          <a:xfrm>
            <a:off x="328896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7"/>
          <p:cNvSpPr>
            <a:spLocks noGrp="1"/>
          </p:cNvSpPr>
          <p:nvPr>
            <p:ph/>
          </p:nvPr>
        </p:nvSpPr>
        <p:spPr>
          <a:xfrm>
            <a:off x="5968800" y="3908520"/>
            <a:ext cx="255168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3328B88-7323-46B7-A3EF-3125F7D3C3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FAF63-9E57-4866-8D51-F9FB2BEFB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15D25-486B-4248-BA88-FCC4B196DB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4876A-C505-4B32-9559-6128513451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194760" y="228600"/>
            <a:ext cx="801540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5E3D7-65CD-4390-9C0E-C5A1BB0067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1659B-6A7D-4B98-823B-0D27E1E7F1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670280" y="390852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F289E-DEE4-4682-8806-307DF420B0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0280" y="1599840"/>
            <a:ext cx="386712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908520"/>
            <a:ext cx="7925040" cy="210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EE2C1-326C-4E60-A149-EE7818C358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Group 2"/>
          <p:cNvGrpSpPr/>
          <p:nvPr/>
        </p:nvGrpSpPr>
        <p:grpSpPr>
          <a:xfrm>
            <a:off x="0" y="152280"/>
            <a:ext cx="8686800" cy="6096240"/>
            <a:chOff x="0" y="152280"/>
            <a:chExt cx="8686800" cy="6096240"/>
          </a:xfrm>
        </p:grpSpPr>
        <p:sp>
          <p:nvSpPr>
            <p:cNvPr id="1" name="AutoShape 3"/>
            <p:cNvSpPr/>
            <p:nvPr/>
          </p:nvSpPr>
          <p:spPr>
            <a:xfrm>
              <a:off x="380880" y="533520"/>
              <a:ext cx="8305920" cy="5715000"/>
            </a:xfrm>
            <a:prstGeom prst="roundRect">
              <a:avLst>
                <a:gd name="adj" fmla="val 13727"/>
              </a:avLst>
            </a:prstGeom>
            <a:noFill/>
            <a:ln w="50760">
              <a:solidFill>
                <a:srgbClr val="38c84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" name="AutoShape 4"/>
            <p:cNvSpPr/>
            <p:nvPr/>
          </p:nvSpPr>
          <p:spPr>
            <a:xfrm>
              <a:off x="0" y="152280"/>
              <a:ext cx="8534520" cy="1219320"/>
            </a:xfrm>
            <a:custGeom>
              <a:avLst/>
              <a:gdLst>
                <a:gd name="textAreaLeft" fmla="*/ 0 w 8534520"/>
                <a:gd name="textAreaRight" fmla="*/ 4267440 w 8534520"/>
                <a:gd name="textAreaTop" fmla="*/ 0 h 1219320"/>
                <a:gd name="textAreaBottom" fmla="*/ 1219680 h 1219320"/>
              </a:gdLst>
              <a:ahLst/>
              <a:rect l="textAreaLeft" t="textAreaTop" r="textAreaRight" b="textAreaBottom"/>
              <a:pathLst>
                <a:path w="7000" h="1000">
                  <a:moveTo>
                    <a:pt x="0" y="0"/>
                  </a:moveTo>
                  <a:lnTo>
                    <a:pt x="6499" y="0"/>
                  </a:lnTo>
                  <a:cubicBezTo>
                    <a:pt x="6776" y="0"/>
                    <a:pt x="7000" y="223"/>
                    <a:pt x="7000" y="500"/>
                  </a:cubicBezTo>
                  <a:cubicBezTo>
                    <a:pt x="7000" y="776"/>
                    <a:pt x="6776" y="999"/>
                    <a:pt x="6500" y="1000"/>
                  </a:cubicBezTo>
                  <a:lnTo>
                    <a:pt x="0" y="1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c20e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" name="Line 5"/>
            <p:cNvSpPr/>
            <p:nvPr/>
          </p:nvSpPr>
          <p:spPr>
            <a:xfrm>
              <a:off x="0" y="1219320"/>
              <a:ext cx="807732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38c849"/>
              </a:buClr>
              <a:buSzPct val="6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1a2f96"/>
              </a:buClr>
              <a:buSzPct val="6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38c849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dt" idx="1"/>
          </p:nvPr>
        </p:nvSpPr>
        <p:spPr>
          <a:xfrm>
            <a:off x="45684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5"/>
          <p:cNvSpPr>
            <a:spLocks noGrp="1"/>
          </p:cNvSpPr>
          <p:nvPr>
            <p:ph type="sldNum" idx="3"/>
          </p:nvPr>
        </p:nvSpPr>
        <p:spPr>
          <a:xfrm>
            <a:off x="655272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 Black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11500F-8345-45F5-8F86-8EB0C64E7D5D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2"/>
          <p:cNvGrpSpPr/>
          <p:nvPr/>
        </p:nvGrpSpPr>
        <p:grpSpPr>
          <a:xfrm>
            <a:off x="0" y="927000"/>
            <a:ext cx="8991720" cy="4496040"/>
            <a:chOff x="0" y="927000"/>
            <a:chExt cx="8991720" cy="4496040"/>
          </a:xfrm>
        </p:grpSpPr>
        <p:sp>
          <p:nvSpPr>
            <p:cNvPr id="46" name="AutoShape 3"/>
            <p:cNvSpPr/>
            <p:nvPr/>
          </p:nvSpPr>
          <p:spPr>
            <a:xfrm>
              <a:off x="685800" y="2070000"/>
              <a:ext cx="7391520" cy="3353040"/>
            </a:xfrm>
            <a:prstGeom prst="roundRect">
              <a:avLst>
                <a:gd name="adj" fmla="val 16667"/>
              </a:avLst>
            </a:prstGeom>
            <a:noFill/>
            <a:ln w="50760">
              <a:solidFill>
                <a:srgbClr val="38c84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4"/>
            <p:cNvSpPr/>
            <p:nvPr/>
          </p:nvSpPr>
          <p:spPr>
            <a:xfrm>
              <a:off x="228600" y="927000"/>
              <a:ext cx="7162920" cy="99072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38c84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AutoShape 5"/>
            <p:cNvSpPr/>
            <p:nvPr/>
          </p:nvSpPr>
          <p:spPr>
            <a:xfrm>
              <a:off x="0" y="1384200"/>
              <a:ext cx="8991720" cy="1828800"/>
            </a:xfrm>
            <a:custGeom>
              <a:avLst/>
              <a:gdLst>
                <a:gd name="textAreaLeft" fmla="*/ 0 w 8991720"/>
                <a:gd name="textAreaRight" fmla="*/ 4496760 w 8991720"/>
                <a:gd name="textAreaTop" fmla="*/ 0 h 1828800"/>
                <a:gd name="textAreaBottom" fmla="*/ 1829160 h 1828800"/>
              </a:gdLst>
              <a:ahLst/>
              <a:rect l="textAreaLeft" t="textAreaTop" r="textAreaRight" b="textAreaBottom"/>
              <a:pathLst>
                <a:path w="4917" h="1000">
                  <a:moveTo>
                    <a:pt x="0" y="0"/>
                  </a:moveTo>
                  <a:lnTo>
                    <a:pt x="4416" y="0"/>
                  </a:lnTo>
                  <a:cubicBezTo>
                    <a:pt x="4693" y="0"/>
                    <a:pt x="4917" y="223"/>
                    <a:pt x="4917" y="500"/>
                  </a:cubicBezTo>
                  <a:cubicBezTo>
                    <a:pt x="4917" y="776"/>
                    <a:pt x="4693" y="999"/>
                    <a:pt x="4417" y="1000"/>
                  </a:cubicBezTo>
                  <a:lnTo>
                    <a:pt x="0" y="1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c20e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6"/>
            <p:cNvSpPr/>
            <p:nvPr/>
          </p:nvSpPr>
          <p:spPr>
            <a:xfrm>
              <a:off x="0" y="3060720"/>
              <a:ext cx="8305920" cy="0"/>
            </a:xfrm>
            <a:prstGeom prst="line">
              <a:avLst/>
            </a:prstGeom>
            <a:ln w="507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38c849"/>
              </a:buClr>
              <a:buSzPct val="6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1a2f96"/>
              </a:buClr>
              <a:buSzPct val="6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38c849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SzPct val="4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dt" idx="4"/>
          </p:nvPr>
        </p:nvSpPr>
        <p:spPr>
          <a:xfrm>
            <a:off x="456840" y="6248160"/>
            <a:ext cx="2133720" cy="47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4"/>
          <p:cNvSpPr>
            <a:spLocks noGrp="1"/>
          </p:cNvSpPr>
          <p:nvPr>
            <p:ph type="ftr" idx="5"/>
          </p:nvPr>
        </p:nvSpPr>
        <p:spPr>
          <a:xfrm>
            <a:off x="3124080" y="625320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5"/>
          <p:cNvSpPr>
            <a:spLocks noGrp="1"/>
          </p:cNvSpPr>
          <p:nvPr>
            <p:ph type="sldNum" idx="6"/>
          </p:nvPr>
        </p:nvSpPr>
        <p:spPr>
          <a:xfrm>
            <a:off x="6552720" y="6248160"/>
            <a:ext cx="2133720" cy="47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 Black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98DA17-76EF-4E13-BA9D-6007CB6711F1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228240" y="1427040"/>
            <a:ext cx="8077320" cy="1609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600" spc="-1" strike="noStrike">
                <a:solidFill>
                  <a:srgbClr val="ffffff"/>
                </a:solidFill>
                <a:latin typeface="Arial"/>
              </a:rPr>
              <a:t>ten top </a:t>
            </a:r>
            <a:r>
              <a:rPr b="0" lang="en-GB" sz="4600" spc="-1" strike="noStrike">
                <a:solidFill>
                  <a:srgbClr val="38c849"/>
                </a:solidFill>
                <a:latin typeface="Arial"/>
              </a:rPr>
              <a:t>tips</a:t>
            </a:r>
            <a:endParaRPr b="0" lang="en-US" sz="46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99" name="Picture 16" descr=""/>
          <p:cNvPicPr/>
          <p:nvPr/>
        </p:nvPicPr>
        <p:blipFill>
          <a:blip r:embed="rId1"/>
          <a:stretch/>
        </p:blipFill>
        <p:spPr>
          <a:xfrm>
            <a:off x="6684840" y="5996160"/>
            <a:ext cx="2401920" cy="812520"/>
          </a:xfrm>
          <a:prstGeom prst="rect">
            <a:avLst/>
          </a:prstGeom>
          <a:ln w="0">
            <a:noFill/>
          </a:ln>
        </p:spPr>
      </p:pic>
      <p:sp>
        <p:nvSpPr>
          <p:cNvPr id="100" name="PlaceHolder 2"/>
          <p:cNvSpPr>
            <a:spLocks noGrp="1"/>
          </p:cNvSpPr>
          <p:nvPr>
            <p:ph type="subTitle"/>
          </p:nvPr>
        </p:nvSpPr>
        <p:spPr>
          <a:xfrm>
            <a:off x="1066320" y="3441240"/>
            <a:ext cx="6629400" cy="167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Recap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609480" y="1600200"/>
            <a:ext cx="7925040" cy="4565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609480" indent="-6094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Read the ten top tips leafle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Plan how you are going to fit the tips into your daily routin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Do as many of the tips as you can every da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Keep track of how you are doing in the logbook  (really important!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Weigh yourself regularly (really makes a difference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For more information on the ten top tips see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www.weightconcern.org.u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878651-7F81-421E-A031-059284F17AFF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What can you expect?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Changes to your lifestyl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You may already be doing some of the tips – very good, keep it up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With practice the tips will become easie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You might like to seek the support of family and friend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D95EC8-4145-45B3-8967-DF292C7BB3B6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Benefits of following the tips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Moderate weight loss (of up to 0.5kg               or 1 pound a week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More energy, less tire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More able to get involved in activities with friends and famil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Reduced risk of developing diabetes, heart disease, some cance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4" descr="Copy of older couple"/>
          <p:cNvPicPr/>
          <p:nvPr/>
        </p:nvPicPr>
        <p:blipFill>
          <a:blip r:embed="rId1"/>
          <a:stretch/>
        </p:blipFill>
        <p:spPr>
          <a:xfrm>
            <a:off x="7164360" y="836640"/>
            <a:ext cx="1979640" cy="1319040"/>
          </a:xfrm>
          <a:prstGeom prst="rect">
            <a:avLst/>
          </a:prstGeom>
          <a:ln w="0">
            <a:noFill/>
          </a:ln>
        </p:spPr>
      </p:pic>
      <p:sp>
        <p:nvSpPr>
          <p:cNvPr id="145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3AAD5F-4EC4-423C-A481-FCEB332FEB6B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Any questions?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31F793-49C0-4FB1-BCE2-4FA32CF591FE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Weight gain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333333"/>
                </a:solidFill>
                <a:latin typeface="Arial"/>
              </a:rPr>
              <a:t>Overweight affects 6 out of 10 adult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333333"/>
                </a:solidFill>
                <a:latin typeface="Arial"/>
              </a:rPr>
              <a:t>Weight often goes on gradually over several year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333333"/>
                </a:solidFill>
                <a:latin typeface="Arial"/>
              </a:rPr>
              <a:t>We don’t fully understand why some people gain weight more easily than others, but it’s partly in the gene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333333"/>
                </a:solidFill>
                <a:latin typeface="Arial"/>
              </a:rPr>
              <a:t>We know that overweight and obesity affect health and quality of life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EBEB64-BB6D-4780-BE06-7E61EFB37BDF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Losing weight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Keep it simple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Make changes to your lifestyle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Get into healthy habit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Losing small amounts of weight (5-10% of your current weight) can still make a difference to your health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EBA339-2890-4991-B6B4-3C08AA9F5E76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ten top </a:t>
            </a:r>
            <a:r>
              <a:rPr b="0" lang="en-GB" sz="4200" spc="-1" strike="noStrike">
                <a:solidFill>
                  <a:srgbClr val="38c849"/>
                </a:solidFill>
                <a:latin typeface="Arial"/>
              </a:rPr>
              <a:t>tips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609120" y="1599840"/>
            <a:ext cx="641052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64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600" spc="-1" strike="noStrike">
                <a:solidFill>
                  <a:srgbClr val="000000"/>
                </a:solidFill>
                <a:latin typeface="Arial"/>
              </a:rPr>
              <a:t>ten top tips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is about forming </a:t>
            </a: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healthy habits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to help you lose weight and keep the weight off for good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64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It shows </a:t>
            </a: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ten simple tips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that can be built into your </a:t>
            </a: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daily routine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64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The tips help you to take in </a:t>
            </a: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fewer calories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and burn </a:t>
            </a: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more energy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600" spc="-1" strike="noStrike">
                <a:solidFill>
                  <a:srgbClr val="38c849"/>
                </a:solidFill>
                <a:latin typeface="Arial"/>
              </a:rPr>
              <a:t>Research</a:t>
            </a:r>
            <a:r>
              <a:rPr b="0" lang="en-GB" sz="2600" spc="-1" strike="noStrike">
                <a:solidFill>
                  <a:srgbClr val="000000"/>
                </a:solidFill>
                <a:latin typeface="Arial"/>
              </a:rPr>
              <a:t> shows that following these tips helps people to lose weight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11" descr=""/>
          <p:cNvPicPr/>
          <p:nvPr/>
        </p:nvPicPr>
        <p:blipFill>
          <a:blip r:embed="rId1"/>
          <a:stretch/>
        </p:blipFill>
        <p:spPr>
          <a:xfrm rot="691800">
            <a:off x="7030800" y="582120"/>
            <a:ext cx="1866600" cy="2654280"/>
          </a:xfrm>
          <a:prstGeom prst="rect">
            <a:avLst/>
          </a:prstGeom>
          <a:ln w="0">
            <a:noFill/>
          </a:ln>
        </p:spPr>
      </p:pic>
      <p:sp>
        <p:nvSpPr>
          <p:cNvPr id="110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B4B40E-3C3A-4D64-BC60-A5BFA2CFF8E8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Healthy Habits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610920" y="1483920"/>
            <a:ext cx="7924680" cy="4925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A habit is something you do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automatically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, like tying your shoelaces or brushing your teeth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Habits are formed when you do something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over and over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 again in the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same place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 or at the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same tim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We know that habits can affect our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health </a:t>
            </a: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in different ways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e.g. Regularly having a second helping of dinner might make it more difficult to manage our weigh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ts val="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333333"/>
                </a:solidFill>
                <a:latin typeface="Arial"/>
              </a:rPr>
              <a:t>Getting into a routine and practising the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healthy tips</a:t>
            </a:r>
            <a:r>
              <a:rPr b="0" lang="en-GB" sz="2400" spc="-1" strike="noStrike">
                <a:solidFill>
                  <a:srgbClr val="333333"/>
                </a:solidFill>
                <a:latin typeface="Arial"/>
              </a:rPr>
              <a:t> 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every day</a:t>
            </a:r>
            <a:r>
              <a:rPr b="0" lang="en-GB" sz="2400" spc="-1" strike="noStrike">
                <a:solidFill>
                  <a:srgbClr val="333333"/>
                </a:solidFill>
                <a:latin typeface="Arial"/>
              </a:rPr>
              <a:t>, helps turn them into</a:t>
            </a:r>
            <a:r>
              <a:rPr b="0" lang="en-GB" sz="2400" spc="-1" strike="noStrike">
                <a:solidFill>
                  <a:srgbClr val="38c849"/>
                </a:solidFill>
                <a:latin typeface="Arial"/>
              </a:rPr>
              <a:t> healthy habit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B7510B-F420-4CCF-8C31-DCFA6A064F54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Picture 4" descr=""/>
          <p:cNvPicPr/>
          <p:nvPr/>
        </p:nvPicPr>
        <p:blipFill>
          <a:blip r:embed="rId1"/>
          <a:stretch/>
        </p:blipFill>
        <p:spPr>
          <a:xfrm rot="1236600">
            <a:off x="7235640" y="189000"/>
            <a:ext cx="1569960" cy="2014560"/>
          </a:xfrm>
          <a:prstGeom prst="rect">
            <a:avLst/>
          </a:prstGeom>
          <a:ln w="0">
            <a:noFill/>
          </a:ln>
        </p:spPr>
      </p:pic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Turning the tips into habits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Plan ahead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How will you fit the tips into your daily routine?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Making a plan increases your chances of doing somethin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Be prepare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Do you need to do anything differently (e.g. pack walking shoes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Repeat the tips at the same time or in the same plac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99ccff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This makes it more likely that you will form habi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Keep track of your progress in the logbook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5" descr="MCj04349290000[1]"/>
          <p:cNvPicPr/>
          <p:nvPr/>
        </p:nvPicPr>
        <p:blipFill>
          <a:blip r:embed="rId2"/>
          <a:stretch/>
        </p:blipFill>
        <p:spPr>
          <a:xfrm>
            <a:off x="7020000" y="4581360"/>
            <a:ext cx="1828800" cy="1828800"/>
          </a:xfrm>
          <a:prstGeom prst="rect">
            <a:avLst/>
          </a:prstGeom>
          <a:ln w="0">
            <a:noFill/>
          </a:ln>
        </p:spPr>
      </p:pic>
      <p:sp>
        <p:nvSpPr>
          <p:cNvPr id="118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8F3677-474B-4515-8CDF-C64A1BACE0DF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/>
          </p:nvPr>
        </p:nvSpPr>
        <p:spPr>
          <a:xfrm>
            <a:off x="539640" y="1700280"/>
            <a:ext cx="8353440" cy="3890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609480" indent="0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600" spc="-1" strike="noStrike">
                <a:solidFill>
                  <a:srgbClr val="000000"/>
                </a:solidFill>
                <a:latin typeface="Arial"/>
              </a:rPr>
              <a:t>When? 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Walking part of your journey each da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0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600" spc="-1" strike="noStrike">
                <a:solidFill>
                  <a:srgbClr val="000000"/>
                </a:solidFill>
                <a:latin typeface="Arial"/>
              </a:rPr>
              <a:t>How?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Get of the bus a few stops earlie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Leave extra time for your journey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Plan a route and pack an umbrell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Use the tick sheet to track your progres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5" descr=""/>
          <p:cNvPicPr/>
          <p:nvPr/>
        </p:nvPicPr>
        <p:blipFill>
          <a:blip r:embed="rId1"/>
          <a:srcRect l="0" t="0" r="2434" b="3993"/>
          <a:stretch/>
        </p:blipFill>
        <p:spPr>
          <a:xfrm>
            <a:off x="611280" y="404640"/>
            <a:ext cx="4248000" cy="1148040"/>
          </a:xfrm>
          <a:prstGeom prst="rect">
            <a:avLst/>
          </a:prstGeom>
          <a:ln w="0">
            <a:noFill/>
          </a:ln>
        </p:spPr>
      </p:pic>
      <p:sp>
        <p:nvSpPr>
          <p:cNvPr id="121" name="PlaceHolder 2"/>
          <p:cNvSpPr>
            <a:spLocks noGrp="1"/>
          </p:cNvSpPr>
          <p:nvPr>
            <p:ph type="title"/>
          </p:nvPr>
        </p:nvSpPr>
        <p:spPr>
          <a:xfrm>
            <a:off x="611280" y="260280"/>
            <a:ext cx="801504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	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22" name="Picture 7" descr=""/>
          <p:cNvPicPr/>
          <p:nvPr/>
        </p:nvPicPr>
        <p:blipFill>
          <a:blip r:embed="rId2"/>
          <a:stretch/>
        </p:blipFill>
        <p:spPr>
          <a:xfrm>
            <a:off x="826920" y="5084640"/>
            <a:ext cx="6985080" cy="1163880"/>
          </a:xfrm>
          <a:prstGeom prst="rect">
            <a:avLst/>
          </a:prstGeom>
          <a:ln w="0">
            <a:noFill/>
          </a:ln>
        </p:spPr>
      </p:pic>
      <p:sp>
        <p:nvSpPr>
          <p:cNvPr id="123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B73FAF-BB4F-4C37-A960-96E7AA446BE9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7" dur="500"/>
                                        <p:tgtEl>
                                          <p:spTgt spid="11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nodeType="clickEffect" fill="hold">
                      <p:stCondLst>
                        <p:cond delay="indefinite"/>
                      </p:stCondLst>
                      <p:childTnLst>
                        <p:par>
                          <p:cTn id="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0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2" dur="500"/>
                                        <p:tgtEl>
                                          <p:spTgt spid="11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nodeType="clickEffect" fill="hold">
                      <p:stCondLst>
                        <p:cond delay="indefinite"/>
                      </p:stCondLst>
                      <p:childTnLst>
                        <p:par>
                          <p:cTn id="1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5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7" dur="500"/>
                                        <p:tgtEl>
                                          <p:spTgt spid="11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nodeType="clickEffect" fill="hold">
                      <p:stCondLst>
                        <p:cond delay="indefinite"/>
                      </p:stCondLst>
                      <p:childTnLst>
                        <p:par>
                          <p:cTn id="1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0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22" dur="500"/>
                                        <p:tgtEl>
                                          <p:spTgt spid="11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nodeType="clickEffect" fill="hold">
                      <p:stCondLst>
                        <p:cond delay="indefinite"/>
                      </p:stCondLst>
                      <p:childTnLst>
                        <p:par>
                          <p:cTn id="2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5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27" dur="500"/>
                                        <p:tgtEl>
                                          <p:spTgt spid="11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nodeType="clickEffect" fill="hold">
                      <p:stCondLst>
                        <p:cond delay="indefinite"/>
                      </p:stCondLst>
                      <p:childTnLst>
                        <p:par>
                          <p:cTn id="2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30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32" dur="500"/>
                                        <p:tgtEl>
                                          <p:spTgt spid="11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nodeType="clickEffect" fill="hold">
                      <p:stCondLst>
                        <p:cond delay="indefinite"/>
                      </p:stCondLst>
                      <p:childTnLst>
                        <p:par>
                          <p:cTn id="3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35" nodeType="click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37" dur="500"/>
                                        <p:tgtEl>
                                          <p:spTgt spid="119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" name=""/>
          <p:cNvSpPr txBox="1"/>
          <p:nvPr/>
        </p:nvSpPr>
        <p:spPr>
          <a:xfrm>
            <a:off x="609480" y="1600200"/>
            <a:ext cx="7925040" cy="3341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4000"/>
          </a:bodyPr>
          <a:p>
            <a:pPr marL="322200" indent="-322200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600" spc="-1" strike="noStrike">
                <a:solidFill>
                  <a:srgbClr val="000000"/>
                </a:solidFill>
                <a:latin typeface="Arial"/>
              </a:rPr>
              <a:t>When?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Have smaller portions at meal tim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600" spc="-1" strike="noStrike">
                <a:solidFill>
                  <a:srgbClr val="000000"/>
                </a:solidFill>
                <a:latin typeface="Arial"/>
              </a:rPr>
              <a:t>How?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Use a smaller plat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Fill your plate with vegetables before adding the rest of the foo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Resist having second helpings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Cook a smaller amount of food or freeze leftove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22200" indent="-322200">
              <a:spcBef>
                <a:spcPts val="601"/>
              </a:spcBef>
              <a:buClr>
                <a:srgbClr val="1a2f96"/>
              </a:buClr>
              <a:buSzPct val="80000"/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lide Number Placeholder 4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9B6682-50CB-4F2A-9D1B-9F456D1E5B21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2" descr=""/>
          <p:cNvPicPr/>
          <p:nvPr/>
        </p:nvPicPr>
        <p:blipFill>
          <a:blip r:embed="rId1"/>
          <a:stretch/>
        </p:blipFill>
        <p:spPr>
          <a:xfrm>
            <a:off x="654120" y="404640"/>
            <a:ext cx="4217760" cy="110196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5" descr=""/>
          <p:cNvPicPr/>
          <p:nvPr/>
        </p:nvPicPr>
        <p:blipFill>
          <a:blip r:embed="rId2"/>
          <a:stretch/>
        </p:blipFill>
        <p:spPr>
          <a:xfrm>
            <a:off x="826920" y="5373720"/>
            <a:ext cx="7581960" cy="115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194760" y="228600"/>
            <a:ext cx="80154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200" spc="-1" strike="noStrike">
                <a:solidFill>
                  <a:srgbClr val="ffffff"/>
                </a:solidFill>
                <a:latin typeface="Arial"/>
              </a:rPr>
              <a:t>Fitting the tips into your life </a:t>
            </a:r>
            <a:endParaRPr b="0" lang="en-US" sz="4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609480" y="1599840"/>
            <a:ext cx="7925040" cy="4419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Tip: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When will you do it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1a2f96"/>
              </a:buClr>
              <a:buSzPct val="8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Arial"/>
              </a:rPr>
              <a:t>How will you do it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4"/>
          <p:cNvSpPr/>
          <p:nvPr/>
        </p:nvSpPr>
        <p:spPr>
          <a:xfrm>
            <a:off x="1835280" y="2060640"/>
            <a:ext cx="4465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5"/>
          <p:cNvSpPr/>
          <p:nvPr/>
        </p:nvSpPr>
        <p:spPr>
          <a:xfrm>
            <a:off x="826920" y="3860640"/>
            <a:ext cx="7129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6"/>
          <p:cNvSpPr/>
          <p:nvPr/>
        </p:nvSpPr>
        <p:spPr>
          <a:xfrm>
            <a:off x="755640" y="5013360"/>
            <a:ext cx="7129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7"/>
          <p:cNvSpPr/>
          <p:nvPr/>
        </p:nvSpPr>
        <p:spPr>
          <a:xfrm>
            <a:off x="755640" y="5589720"/>
            <a:ext cx="7129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Slide Number Placeholder 1"/>
          <p:cNvSpPr/>
          <p:nvPr/>
        </p:nvSpPr>
        <p:spPr>
          <a:xfrm>
            <a:off x="655308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8E36C0-E3A9-4BAC-BC87-47CB6D1E5271}" type="slidenum">
              <a:rPr b="0" lang="en-US" sz="1200" spc="-1" strike="noStrike">
                <a:solidFill>
                  <a:srgbClr val="000000"/>
                </a:solidFill>
                <a:latin typeface="Arial Black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5T13:07:07Z</dcterms:created>
  <dc:creator>Kate Evans</dc:creator>
  <dc:description/>
  <dc:language>en-US</dc:language>
  <cp:lastModifiedBy>R J ( Becca ) Beeken</cp:lastModifiedBy>
  <cp:lastPrinted>2011-05-06T11:00:48Z</cp:lastPrinted>
  <dcterms:modified xsi:type="dcterms:W3CDTF">2013-02-14T16:52:09Z</dcterms:modified>
  <cp:revision>79</cp:revision>
  <dc:subject/>
  <dc:title>Ten top tips</dc:title>
</cp:coreProperties>
</file>